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613BD-8F92-4012-87F6-1E188CBE27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72E34-F0A6-4297-B2EE-8284573849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E61CB-3557-4F0B-B0C5-A1D720AEC4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64288-EA1F-44B9-9D2A-262604CBE8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AB92F-2F1D-413A-934C-EF1EFED814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41E47-BE56-4FE0-9561-F2235A4302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8632F-8062-472A-8B77-5887B5DD91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D9C70-1A81-4DC8-B924-E8E798E7BB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C042D-60DB-48FC-969D-23639A729F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07AEB-9745-4DB9-87A7-25A75A0598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7890F-F330-48B7-84EF-40F73130B4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8C9D8-DFA6-47AF-8BCB-7651F6D64C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160D01-5281-4DB2-8932-5F3EF2337749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2" descr=""/>
          <p:cNvPicPr/>
          <p:nvPr/>
        </p:nvPicPr>
        <p:blipFill>
          <a:blip r:embed="rId1"/>
          <a:srcRect l="18311" t="54690" r="16506" b="23829"/>
          <a:stretch/>
        </p:blipFill>
        <p:spPr>
          <a:xfrm>
            <a:off x="142920" y="357120"/>
            <a:ext cx="8669160" cy="2143080"/>
          </a:xfrm>
          <a:prstGeom prst="rect">
            <a:avLst/>
          </a:prstGeom>
          <a:ln w="0">
            <a:noFill/>
          </a:ln>
        </p:spPr>
      </p:pic>
      <p:sp>
        <p:nvSpPr>
          <p:cNvPr id="42" name="Straight Connector 3"/>
          <p:cNvSpPr/>
          <p:nvPr/>
        </p:nvSpPr>
        <p:spPr>
          <a:xfrm flipH="1">
            <a:off x="2855520" y="1143000"/>
            <a:ext cx="1800" cy="57168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4"/>
          <p:cNvSpPr/>
          <p:nvPr/>
        </p:nvSpPr>
        <p:spPr>
          <a:xfrm flipH="1" flipV="1">
            <a:off x="2643120" y="1143000"/>
            <a:ext cx="214560" cy="144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5"/>
          <p:cNvSpPr/>
          <p:nvPr/>
        </p:nvSpPr>
        <p:spPr>
          <a:xfrm flipH="1" flipV="1">
            <a:off x="2643120" y="1712520"/>
            <a:ext cx="214560" cy="1800"/>
          </a:xfrm>
          <a:prstGeom prst="line">
            <a:avLst/>
          </a:prstGeom>
          <a:ln w="381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5"/>
          <p:cNvSpPr/>
          <p:nvPr/>
        </p:nvSpPr>
        <p:spPr>
          <a:xfrm>
            <a:off x="2857680" y="1263600"/>
            <a:ext cx="3357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4f81bd"/>
                </a:solidFill>
                <a:latin typeface="Calibri"/>
              </a:rPr>
              <a:t>CHROMOSOME 8 PSEUDOGEN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7"/>
          <p:cNvSpPr/>
          <p:nvPr/>
        </p:nvSpPr>
        <p:spPr>
          <a:xfrm flipH="1">
            <a:off x="1784520" y="500040"/>
            <a:ext cx="1440" cy="57168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8"/>
          <p:cNvSpPr/>
          <p:nvPr/>
        </p:nvSpPr>
        <p:spPr>
          <a:xfrm flipH="1" flipV="1">
            <a:off x="1571400" y="500040"/>
            <a:ext cx="214200" cy="144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9"/>
          <p:cNvSpPr/>
          <p:nvPr/>
        </p:nvSpPr>
        <p:spPr>
          <a:xfrm flipH="1" flipV="1">
            <a:off x="1571400" y="1069560"/>
            <a:ext cx="214200" cy="18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9"/>
          <p:cNvSpPr/>
          <p:nvPr/>
        </p:nvSpPr>
        <p:spPr>
          <a:xfrm>
            <a:off x="1785960" y="620640"/>
            <a:ext cx="3357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ff0000"/>
                </a:solidFill>
                <a:latin typeface="Calibri"/>
              </a:rPr>
              <a:t>CHROMOSOME 8 INTACT OR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0" y="2714760"/>
            <a:ext cx="87868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le 3: </a:t>
            </a: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Human chromosome 8 DUB/USP17 family members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hylogenetic tree of the identified human DUB/USP17 DNA sequences from chromosome 8 generated using a ClustalW2 alignmen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The sequence accession numbers are as follows; LOC401447 (GenBank: XR_040280); USP17L4 (GenBank: XM_001720370); LOC402329 (GenBank: NM_000008 Region 7199348 to 7200548); LOC392187 (GenBank: NC_00008 Region 7824866 to 7826066); USP17L8 (GenBank: XM_001720762); USP17L3 (GenBank: XM_001720764); LOC392196 (GenBank: NR_003275); USP17L7 (GenBank: XM_373243); DUB-3 (GenBank: NM_201402)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21T12:08:05Z</dcterms:created>
  <dc:creator>QUB</dc:creator>
  <dc:description/>
  <dc:language>en-US</dc:language>
  <cp:lastModifiedBy>QUB</cp:lastModifiedBy>
  <dcterms:modified xsi:type="dcterms:W3CDTF">2010-04-12T14:01:48Z</dcterms:modified>
  <cp:revision>3</cp:revision>
  <dc:subject/>
  <dc:title>Slide 1</dc:title>
</cp:coreProperties>
</file>